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476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e\Desktop\meningioma\tissue%20if%2045%206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4</c:f>
              <c:strCache>
                <c:ptCount val="1"/>
                <c:pt idx="0">
                  <c:v>Jed62_MN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2!$B$7:$H$7</c:f>
                <c:numCache>
                  <c:formatCode>General</c:formatCode>
                  <c:ptCount val="7"/>
                  <c:pt idx="0">
                    <c:v>0.55878561048551234</c:v>
                  </c:pt>
                  <c:pt idx="1">
                    <c:v>0</c:v>
                  </c:pt>
                  <c:pt idx="2">
                    <c:v>0.10529859379027252</c:v>
                  </c:pt>
                  <c:pt idx="3">
                    <c:v>0</c:v>
                  </c:pt>
                  <c:pt idx="4">
                    <c:v>2.7593862121051216</c:v>
                  </c:pt>
                  <c:pt idx="5">
                    <c:v>0.14836795252225546</c:v>
                  </c:pt>
                  <c:pt idx="6">
                    <c:v>12.780255663391161</c:v>
                  </c:pt>
                </c:numCache>
              </c:numRef>
            </c:plus>
            <c:minus>
              <c:numRef>
                <c:f>Sheet2!$B$7:$H$7</c:f>
                <c:numCache>
                  <c:formatCode>General</c:formatCode>
                  <c:ptCount val="7"/>
                  <c:pt idx="0">
                    <c:v>0.55878561048551234</c:v>
                  </c:pt>
                  <c:pt idx="1">
                    <c:v>0</c:v>
                  </c:pt>
                  <c:pt idx="2">
                    <c:v>0.10529859379027252</c:v>
                  </c:pt>
                  <c:pt idx="3">
                    <c:v>0</c:v>
                  </c:pt>
                  <c:pt idx="4">
                    <c:v>2.7593862121051216</c:v>
                  </c:pt>
                  <c:pt idx="5">
                    <c:v>0.14836795252225546</c:v>
                  </c:pt>
                  <c:pt idx="6">
                    <c:v>12.780255663391161</c:v>
                  </c:pt>
                </c:numCache>
              </c:numRef>
            </c:minus>
          </c:errBars>
          <c:cat>
            <c:strRef>
              <c:f>Sheet2!$B$3:$H$3</c:f>
              <c:strCache>
                <c:ptCount val="7"/>
                <c:pt idx="0">
                  <c:v>Ki67+Nestin-</c:v>
                </c:pt>
                <c:pt idx="1">
                  <c:v>Ki67+Nestin+</c:v>
                </c:pt>
                <c:pt idx="2">
                  <c:v>CD133+Sox2-</c:v>
                </c:pt>
                <c:pt idx="3">
                  <c:v>CD133+Sox2+</c:v>
                </c:pt>
                <c:pt idx="4">
                  <c:v>AGR2+</c:v>
                </c:pt>
                <c:pt idx="5">
                  <c:v>AGR2+BMI+</c:v>
                </c:pt>
                <c:pt idx="6">
                  <c:v>Vimintin+</c:v>
                </c:pt>
              </c:strCache>
            </c:strRef>
          </c:cat>
          <c:val>
            <c:numRef>
              <c:f>Sheet2!$B$4:$H$4</c:f>
              <c:numCache>
                <c:formatCode>General</c:formatCode>
                <c:ptCount val="7"/>
                <c:pt idx="0">
                  <c:v>0.78246440992270683</c:v>
                </c:pt>
                <c:pt idx="1">
                  <c:v>0</c:v>
                </c:pt>
                <c:pt idx="2">
                  <c:v>0.23633192556610991</c:v>
                </c:pt>
                <c:pt idx="3">
                  <c:v>0</c:v>
                </c:pt>
                <c:pt idx="4">
                  <c:v>5.0155473501772532</c:v>
                </c:pt>
                <c:pt idx="5">
                  <c:v>0.14836795252225546</c:v>
                </c:pt>
                <c:pt idx="6">
                  <c:v>48.729218661501569</c:v>
                </c:pt>
              </c:numCache>
            </c:numRef>
          </c:val>
        </c:ser>
        <c:ser>
          <c:idx val="1"/>
          <c:order val="1"/>
          <c:tx>
            <c:strRef>
              <c:f>Sheet2!$A$5</c:f>
              <c:strCache>
                <c:ptCount val="1"/>
                <c:pt idx="0">
                  <c:v>Jed45_M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2!$B$8:$H$8</c:f>
                <c:numCache>
                  <c:formatCode>General</c:formatCode>
                  <c:ptCount val="7"/>
                  <c:pt idx="0">
                    <c:v>1.9396868465378869</c:v>
                  </c:pt>
                  <c:pt idx="1">
                    <c:v>1.9535023792630601</c:v>
                  </c:pt>
                  <c:pt idx="2">
                    <c:v>10.583922926670951</c:v>
                  </c:pt>
                  <c:pt idx="3">
                    <c:v>3.8555041431690427</c:v>
                  </c:pt>
                  <c:pt idx="4">
                    <c:v>12.483105483119449</c:v>
                  </c:pt>
                  <c:pt idx="5">
                    <c:v>10.317523307401252</c:v>
                  </c:pt>
                  <c:pt idx="6">
                    <c:v>3.37381860194066</c:v>
                  </c:pt>
                </c:numCache>
              </c:numRef>
            </c:plus>
            <c:minus>
              <c:numRef>
                <c:f>Sheet2!$B$8:$H$8</c:f>
                <c:numCache>
                  <c:formatCode>General</c:formatCode>
                  <c:ptCount val="7"/>
                  <c:pt idx="0">
                    <c:v>1.9396868465378869</c:v>
                  </c:pt>
                  <c:pt idx="1">
                    <c:v>1.9535023792630601</c:v>
                  </c:pt>
                  <c:pt idx="2">
                    <c:v>10.583922926670951</c:v>
                  </c:pt>
                  <c:pt idx="3">
                    <c:v>3.8555041431690427</c:v>
                  </c:pt>
                  <c:pt idx="4">
                    <c:v>12.483105483119449</c:v>
                  </c:pt>
                  <c:pt idx="5">
                    <c:v>10.317523307401252</c:v>
                  </c:pt>
                  <c:pt idx="6">
                    <c:v>3.37381860194066</c:v>
                  </c:pt>
                </c:numCache>
              </c:numRef>
            </c:minus>
          </c:errBars>
          <c:cat>
            <c:strRef>
              <c:f>Sheet2!$B$3:$H$3</c:f>
              <c:strCache>
                <c:ptCount val="7"/>
                <c:pt idx="0">
                  <c:v>Ki67+Nestin-</c:v>
                </c:pt>
                <c:pt idx="1">
                  <c:v>Ki67+Nestin+</c:v>
                </c:pt>
                <c:pt idx="2">
                  <c:v>CD133+Sox2-</c:v>
                </c:pt>
                <c:pt idx="3">
                  <c:v>CD133+Sox2+</c:v>
                </c:pt>
                <c:pt idx="4">
                  <c:v>AGR2+</c:v>
                </c:pt>
                <c:pt idx="5">
                  <c:v>AGR2+BMI+</c:v>
                </c:pt>
                <c:pt idx="6">
                  <c:v>Vimintin+</c:v>
                </c:pt>
              </c:strCache>
            </c:strRef>
          </c:cat>
          <c:val>
            <c:numRef>
              <c:f>Sheet2!$B$5:$H$5</c:f>
              <c:numCache>
                <c:formatCode>General</c:formatCode>
                <c:ptCount val="7"/>
                <c:pt idx="0">
                  <c:v>4.3119577997458158</c:v>
                </c:pt>
                <c:pt idx="1">
                  <c:v>4.442812772690516</c:v>
                </c:pt>
                <c:pt idx="2">
                  <c:v>41.808970495463022</c:v>
                </c:pt>
                <c:pt idx="3">
                  <c:v>12.025197809792827</c:v>
                </c:pt>
                <c:pt idx="4">
                  <c:v>45.566006857751994</c:v>
                </c:pt>
                <c:pt idx="5">
                  <c:v>25.134096731910915</c:v>
                </c:pt>
                <c:pt idx="6">
                  <c:v>90.1790691251141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6935312"/>
        <c:axId val="560121288"/>
      </c:barChart>
      <c:catAx>
        <c:axId val="4169353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560121288"/>
        <c:crosses val="autoZero"/>
        <c:auto val="1"/>
        <c:lblAlgn val="ctr"/>
        <c:lblOffset val="100"/>
        <c:noMultiLvlLbl val="0"/>
      </c:catAx>
      <c:valAx>
        <c:axId val="56012128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Percentage of </a:t>
                </a:r>
                <a:r>
                  <a:rPr lang="en-US" b="0" dirty="0" smtClean="0"/>
                  <a:t>Cells </a:t>
                </a:r>
                <a:r>
                  <a:rPr lang="en-US" b="0" dirty="0"/>
                  <a:t>% </a:t>
                </a:r>
              </a:p>
            </c:rich>
          </c:tx>
          <c:layout>
            <c:manualLayout>
              <c:xMode val="edge"/>
              <c:yMode val="edge"/>
              <c:x val="2.8997628728131688E-2"/>
              <c:y val="5.5555582558366172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416935312"/>
        <c:crosses val="autoZero"/>
        <c:crossBetween val="between"/>
      </c:valAx>
    </c:plotArea>
    <c:legend>
      <c:legendPos val="b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F81A1-9AA3-4BCE-A4F3-7152C13AB8CE}" type="datetimeFigureOut">
              <a:rPr lang="en-US" smtClean="0"/>
              <a:pPr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4E431-5ABE-473A-86F1-985E3144FD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chart" Target="../charts/chart1.xml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08472" y="183740"/>
            <a:ext cx="3692128" cy="8475676"/>
            <a:chOff x="1108472" y="183740"/>
            <a:chExt cx="3692128" cy="8475676"/>
          </a:xfrm>
        </p:grpSpPr>
        <p:pic>
          <p:nvPicPr>
            <p:cNvPr id="6" name="Picture 2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524000" y="4295236"/>
              <a:ext cx="1600200" cy="11989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4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200400" y="4295236"/>
              <a:ext cx="1600200" cy="11989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TextBox 7"/>
            <p:cNvSpPr txBox="1">
              <a:spLocks noChangeArrowheads="1"/>
            </p:cNvSpPr>
            <p:nvPr/>
          </p:nvSpPr>
          <p:spPr bwMode="auto">
            <a:xfrm>
              <a:off x="3505200" y="228600"/>
              <a:ext cx="115706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1400" dirty="0" smtClean="0">
                  <a:latin typeface="Times New Roman" pitchFamily="18" charset="0"/>
                  <a:cs typeface="Times New Roman" pitchFamily="18" charset="0"/>
                </a:rPr>
                <a:t>Jed45_MN</a:t>
              </a:r>
              <a:endParaRPr lang="en-GB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27"/>
            <p:cNvSpPr txBox="1">
              <a:spLocks noChangeArrowheads="1"/>
            </p:cNvSpPr>
            <p:nvPr/>
          </p:nvSpPr>
          <p:spPr bwMode="auto">
            <a:xfrm>
              <a:off x="1676400" y="228600"/>
              <a:ext cx="983976" cy="2308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1400" dirty="0" smtClean="0">
                  <a:latin typeface="Times New Roman" pitchFamily="18" charset="0"/>
                  <a:cs typeface="Times New Roman" pitchFamily="18" charset="0"/>
                </a:rPr>
                <a:t>Jed62_MN</a:t>
              </a:r>
              <a:endParaRPr lang="en-GB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18"/>
            <p:cNvSpPr txBox="1">
              <a:spLocks noChangeArrowheads="1"/>
            </p:cNvSpPr>
            <p:nvPr/>
          </p:nvSpPr>
          <p:spPr bwMode="auto">
            <a:xfrm rot="16200000">
              <a:off x="801401" y="4756204"/>
              <a:ext cx="99097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AGR2</a:t>
              </a:r>
              <a:r>
                <a:rPr lang="en-US" altLang="en-US" sz="12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en-US" sz="1200" dirty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BMI1</a:t>
              </a:r>
              <a:endParaRPr lang="en-GB" altLang="en-US" sz="1200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36"/>
            <p:cNvSpPr txBox="1">
              <a:spLocks noChangeArrowheads="1"/>
            </p:cNvSpPr>
            <p:nvPr/>
          </p:nvSpPr>
          <p:spPr bwMode="auto">
            <a:xfrm>
              <a:off x="4191000" y="5486400"/>
              <a:ext cx="523875" cy="2309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100µm</a:t>
              </a:r>
              <a:endParaRPr lang="en-GB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4361439" y="5782058"/>
              <a:ext cx="265001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>
              <a:spLocks noChangeArrowheads="1"/>
            </p:cNvSpPr>
            <p:nvPr/>
          </p:nvSpPr>
          <p:spPr bwMode="auto">
            <a:xfrm>
              <a:off x="1108472" y="183740"/>
              <a:ext cx="263129" cy="2774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14" name="TextBox 19"/>
            <p:cNvSpPr txBox="1">
              <a:spLocks noChangeArrowheads="1"/>
            </p:cNvSpPr>
            <p:nvPr/>
          </p:nvSpPr>
          <p:spPr bwMode="auto">
            <a:xfrm>
              <a:off x="1184671" y="5562600"/>
              <a:ext cx="263129" cy="2774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Times New Roman" pitchFamily="18" charset="0"/>
                  <a:cs typeface="Times New Roman" pitchFamily="18" charset="0"/>
                </a:rPr>
                <a:t>B</a:t>
              </a: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1787345"/>
              <a:ext cx="1597739" cy="1198304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3041290"/>
              <a:ext cx="1597739" cy="1198304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 rot="16200000">
              <a:off x="779113" y="2284277"/>
              <a:ext cx="1035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Nestin</a:t>
              </a:r>
              <a:r>
                <a:rPr lang="en-US" sz="12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Ki67</a:t>
              </a:r>
              <a:endParaRPr lang="en-US" sz="1200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736423" y="3546166"/>
              <a:ext cx="11209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D133</a:t>
              </a:r>
              <a:r>
                <a:rPr lang="en-US" sz="12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ox2</a:t>
              </a:r>
              <a:endParaRPr lang="en-US" sz="1200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687588" y="994053"/>
              <a:ext cx="12186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Negative control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533400"/>
              <a:ext cx="1597739" cy="1198304"/>
            </a:xfrm>
            <a:prstGeom prst="rect">
              <a:avLst/>
            </a:prstGeom>
          </p:spPr>
        </p:pic>
        <p:pic>
          <p:nvPicPr>
            <p:cNvPr id="21" name="Picture 3" descr="G:\meningioma IF 23082016\Jed45_MN 060915\01 N+Ki67\Editied\Levels\E5Jed45_MN 06092015 N+Ki67+Dapi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200400" y="1787426"/>
              <a:ext cx="1597739" cy="1198062"/>
            </a:xfrm>
            <a:prstGeom prst="rect">
              <a:avLst/>
            </a:prstGeom>
            <a:noFill/>
          </p:spPr>
        </p:pic>
        <p:pic>
          <p:nvPicPr>
            <p:cNvPr id="22" name="Picture 4" descr="G:\meningioma IF 23082016\Jed45_MN 060915\02 CD133+Sox2\Editied\New levels 3-18  5-20\2Jed45_MN 06092015 (CD133+Sox2+Dapi)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200400" y="3041331"/>
              <a:ext cx="1597739" cy="1198062"/>
            </a:xfrm>
            <a:prstGeom prst="rect">
              <a:avLst/>
            </a:prstGeom>
            <a:noFill/>
          </p:spPr>
        </p:pic>
        <p:pic>
          <p:nvPicPr>
            <p:cNvPr id="23" name="Picture 5" descr="G:\meningioma IF 23082016\Jed45_MN 060915\-ve control\Editied NEG\Levels\ENEG1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200400" y="533521"/>
              <a:ext cx="1597739" cy="1198062"/>
            </a:xfrm>
            <a:prstGeom prst="rect">
              <a:avLst/>
            </a:prstGeom>
            <a:noFill/>
          </p:spPr>
        </p:pic>
        <p:graphicFrame>
          <p:nvGraphicFramePr>
            <p:cNvPr id="24" name="Chart 23"/>
            <p:cNvGraphicFramePr/>
            <p:nvPr>
              <p:extLst>
                <p:ext uri="{D42A27DB-BD31-4B8C-83A1-F6EECF244321}">
                  <p14:modId xmlns:p14="http://schemas.microsoft.com/office/powerpoint/2010/main" val="2622549526"/>
                </p:ext>
              </p:extLst>
            </p:nvPr>
          </p:nvGraphicFramePr>
          <p:xfrm>
            <a:off x="1219200" y="5840016"/>
            <a:ext cx="3352800" cy="2819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5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e</dc:creator>
  <cp:lastModifiedBy>DEEMA MOHAMAD *************** HUSSAIN</cp:lastModifiedBy>
  <cp:revision>4</cp:revision>
  <dcterms:created xsi:type="dcterms:W3CDTF">2016-11-21T17:21:36Z</dcterms:created>
  <dcterms:modified xsi:type="dcterms:W3CDTF">2017-05-04T13:35:03Z</dcterms:modified>
</cp:coreProperties>
</file>